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12192000" cy="719931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82" d="100"/>
          <a:sy n="82" d="100"/>
        </p:scale>
        <p:origin x="864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78222"/>
            <a:ext cx="9144000" cy="2506427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781306"/>
            <a:ext cx="9144000" cy="1738167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118486-D3CB-444C-BB14-5E7AB3B1AA37}" type="datetimeFigureOut">
              <a:rPr lang="zh-CN" altLang="en-US" smtClean="0"/>
              <a:t>2024/9/1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6DDD66-B3A3-4C13-AD8D-FFC89DAC3B3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1632645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118486-D3CB-444C-BB14-5E7AB3B1AA37}" type="datetimeFigureOut">
              <a:rPr lang="zh-CN" altLang="en-US" smtClean="0"/>
              <a:t>2024/9/1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6DDD66-B3A3-4C13-AD8D-FFC89DAC3B3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9155651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83297"/>
            <a:ext cx="2628900" cy="610108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83297"/>
            <a:ext cx="7734300" cy="6101085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118486-D3CB-444C-BB14-5E7AB3B1AA37}" type="datetimeFigureOut">
              <a:rPr lang="zh-CN" altLang="en-US" smtClean="0"/>
              <a:t>2024/9/1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6DDD66-B3A3-4C13-AD8D-FFC89DAC3B3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2284506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118486-D3CB-444C-BB14-5E7AB3B1AA37}" type="datetimeFigureOut">
              <a:rPr lang="zh-CN" altLang="en-US" smtClean="0"/>
              <a:t>2024/9/1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6DDD66-B3A3-4C13-AD8D-FFC89DAC3B3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1737328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94830"/>
            <a:ext cx="10515600" cy="2994714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817875"/>
            <a:ext cx="10515600" cy="1574849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118486-D3CB-444C-BB14-5E7AB3B1AA37}" type="datetimeFigureOut">
              <a:rPr lang="zh-CN" altLang="en-US" smtClean="0"/>
              <a:t>2024/9/1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6DDD66-B3A3-4C13-AD8D-FFC89DAC3B3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8391756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916484"/>
            <a:ext cx="5181600" cy="456789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916484"/>
            <a:ext cx="5181600" cy="456789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118486-D3CB-444C-BB14-5E7AB3B1AA37}" type="datetimeFigureOut">
              <a:rPr lang="zh-CN" altLang="en-US" smtClean="0"/>
              <a:t>2024/9/1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6DDD66-B3A3-4C13-AD8D-FFC89DAC3B3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6689076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83297"/>
            <a:ext cx="10515600" cy="1391534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1764832"/>
            <a:ext cx="5157787" cy="864917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2629749"/>
            <a:ext cx="5157787" cy="3867965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764832"/>
            <a:ext cx="5183188" cy="864917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629749"/>
            <a:ext cx="5183188" cy="3867965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118486-D3CB-444C-BB14-5E7AB3B1AA37}" type="datetimeFigureOut">
              <a:rPr lang="zh-CN" altLang="en-US" smtClean="0"/>
              <a:t>2024/9/16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6DDD66-B3A3-4C13-AD8D-FFC89DAC3B3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5132910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118486-D3CB-444C-BB14-5E7AB3B1AA37}" type="datetimeFigureOut">
              <a:rPr lang="zh-CN" altLang="en-US" smtClean="0"/>
              <a:t>2024/9/16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6DDD66-B3A3-4C13-AD8D-FFC89DAC3B3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3103688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118486-D3CB-444C-BB14-5E7AB3B1AA37}" type="datetimeFigureOut">
              <a:rPr lang="zh-CN" altLang="en-US" smtClean="0"/>
              <a:t>2024/9/16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6DDD66-B3A3-4C13-AD8D-FFC89DAC3B3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747539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9" y="479954"/>
            <a:ext cx="3932237" cy="167984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1036569"/>
            <a:ext cx="6172200" cy="5116178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9" y="2159794"/>
            <a:ext cx="3932237" cy="4001285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118486-D3CB-444C-BB14-5E7AB3B1AA37}" type="datetimeFigureOut">
              <a:rPr lang="zh-CN" altLang="en-US" smtClean="0"/>
              <a:t>2024/9/1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6DDD66-B3A3-4C13-AD8D-FFC89DAC3B3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5748850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9" y="479954"/>
            <a:ext cx="3932237" cy="167984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1036569"/>
            <a:ext cx="6172200" cy="5116178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9" y="2159794"/>
            <a:ext cx="3932237" cy="4001285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118486-D3CB-444C-BB14-5E7AB3B1AA37}" type="datetimeFigureOut">
              <a:rPr lang="zh-CN" altLang="en-US" smtClean="0"/>
              <a:t>2024/9/1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6DDD66-B3A3-4C13-AD8D-FFC89DAC3B3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1174657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83297"/>
            <a:ext cx="10515600" cy="139153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916484"/>
            <a:ext cx="10515600" cy="456789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672697"/>
            <a:ext cx="2743200" cy="38329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C118486-D3CB-444C-BB14-5E7AB3B1AA37}" type="datetimeFigureOut">
              <a:rPr lang="zh-CN" altLang="en-US" smtClean="0"/>
              <a:t>2024/9/1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672697"/>
            <a:ext cx="4114800" cy="38329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672697"/>
            <a:ext cx="2743200" cy="38329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46DDD66-B3A3-4C13-AD8D-FFC89DAC3B3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9367120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>
            <a:extLst>
              <a:ext uri="{FF2B5EF4-FFF2-40B4-BE49-F238E27FC236}">
                <a16:creationId xmlns:a16="http://schemas.microsoft.com/office/drawing/2014/main" id="{922C270B-6635-AD66-8DE1-81346F4AF9D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039563" y="362041"/>
            <a:ext cx="8112874" cy="6084656"/>
          </a:xfrm>
          <a:prstGeom prst="rect">
            <a:avLst/>
          </a:prstGeom>
        </p:spPr>
      </p:pic>
      <p:sp>
        <p:nvSpPr>
          <p:cNvPr id="2" name="TextBox 1"/>
          <p:cNvSpPr txBox="1"/>
          <p:nvPr/>
        </p:nvSpPr>
        <p:spPr>
          <a:xfrm>
            <a:off x="1059373" y="6497496"/>
            <a:ext cx="9852825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igure S2. Inverse Probability of Treatment Weighting (IPTW) Achieving Covariate Balance Across Three </a:t>
            </a:r>
            <a:r>
              <a:rPr lang="en-US" dirty="0"/>
              <a:t/>
            </a:r>
            <a:br>
              <a:rPr lang="en-US" dirty="0"/>
            </a:br>
            <a:r>
              <a:rPr lang="en-US" dirty="0"/>
              <a:t>Temperature </a:t>
            </a:r>
            <a:r>
              <a:rPr lang="en-US" dirty="0"/>
              <a:t>Variation Groups.</a:t>
            </a:r>
            <a:endParaRPr lang="en-IN" dirty="0"/>
          </a:p>
        </p:txBody>
      </p:sp>
    </p:spTree>
    <p:extLst>
      <p:ext uri="{BB962C8B-B14F-4D97-AF65-F5344CB8AC3E}">
        <p14:creationId xmlns:p14="http://schemas.microsoft.com/office/powerpoint/2010/main" val="370478870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</TotalTime>
  <Words>21</Words>
  <Application>Microsoft Office PowerPoint</Application>
  <PresentationFormat>Custom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等线</vt:lpstr>
      <vt:lpstr>Office 主题​​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倩 蔡</dc:creator>
  <cp:lastModifiedBy>Karthikeyan S</cp:lastModifiedBy>
  <cp:revision>2</cp:revision>
  <dcterms:created xsi:type="dcterms:W3CDTF">2024-03-20T03:10:48Z</dcterms:created>
  <dcterms:modified xsi:type="dcterms:W3CDTF">2024-09-16T12:18:39Z</dcterms:modified>
</cp:coreProperties>
</file>